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05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vi\Dropbox\EMT-PCR\shPPARD\SUMMARY%20%20shPPARD%20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054436775723895E-2"/>
          <c:y val="0.189276792301175"/>
          <c:w val="0.894220489736539"/>
          <c:h val="0.747534298189233"/>
        </c:manualLayout>
      </c:layout>
      <c:barChart>
        <c:barDir val="col"/>
        <c:grouping val="clustered"/>
        <c:varyColors val="0"/>
        <c:ser>
          <c:idx val="0"/>
          <c:order val="0"/>
          <c:tx>
            <c:v>NT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Hoja1!$E$21:$E$24;Hoja1!$I$21:$I$24;Hoja1!$M$21:$M$24)</c:f>
                <c:numCache>
                  <c:formatCode>General</c:formatCode>
                  <c:ptCount val="12"/>
                  <c:pt idx="0">
                    <c:v>7.0022703422987997E-2</c:v>
                  </c:pt>
                  <c:pt idx="1">
                    <c:v>0.20581643304569</c:v>
                  </c:pt>
                  <c:pt idx="2">
                    <c:v>0.51773398452168595</c:v>
                  </c:pt>
                  <c:pt idx="3">
                    <c:v>0.11918056054442</c:v>
                  </c:pt>
                  <c:pt idx="4">
                    <c:v>7.5177798305007107E-2</c:v>
                  </c:pt>
                  <c:pt idx="5">
                    <c:v>0.362991918082887</c:v>
                  </c:pt>
                  <c:pt idx="6">
                    <c:v>0.161333172452919</c:v>
                  </c:pt>
                  <c:pt idx="7">
                    <c:v>2.50315474764166</c:v>
                  </c:pt>
                  <c:pt idx="8">
                    <c:v>6.5843623730554093E-2</c:v>
                  </c:pt>
                  <c:pt idx="9">
                    <c:v>0.29643862533787602</c:v>
                  </c:pt>
                  <c:pt idx="10">
                    <c:v>0.61000647679398601</c:v>
                  </c:pt>
                  <c:pt idx="11">
                    <c:v>0.344499894666300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Hoja1!$A$21:$B$36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215</c:v>
                  </c:pt>
                  <c:pt idx="4">
                    <c:v>253</c:v>
                  </c:pt>
                  <c:pt idx="8">
                    <c:v>354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(Hoja1!$C$21:$C$24;Hoja1!$G$21:$G$24;Hoja1!$K$21:$K$24)</c:f>
              <c:numCache>
                <c:formatCode>General</c:formatCode>
                <c:ptCount val="12"/>
                <c:pt idx="0">
                  <c:v>1.0231740698716001</c:v>
                </c:pt>
                <c:pt idx="1">
                  <c:v>2.6709741163777969</c:v>
                </c:pt>
                <c:pt idx="2">
                  <c:v>2.7767330684868101</c:v>
                </c:pt>
                <c:pt idx="3">
                  <c:v>2.2285633976341401</c:v>
                </c:pt>
                <c:pt idx="4">
                  <c:v>1.0237424180904731</c:v>
                </c:pt>
                <c:pt idx="5">
                  <c:v>3.0419884044836731</c:v>
                </c:pt>
                <c:pt idx="6">
                  <c:v>1.906448633555087</c:v>
                </c:pt>
                <c:pt idx="7">
                  <c:v>8.0147978276525187</c:v>
                </c:pt>
                <c:pt idx="8">
                  <c:v>1.02028696493187</c:v>
                </c:pt>
                <c:pt idx="9">
                  <c:v>2.2120009546401191</c:v>
                </c:pt>
                <c:pt idx="10">
                  <c:v>2.9739221977296091</c:v>
                </c:pt>
                <c:pt idx="11">
                  <c:v>2.48707446806474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B6-4EC6-9CE3-C0C604D08C58}"/>
            </c:ext>
          </c:extLst>
        </c:ser>
        <c:ser>
          <c:idx val="1"/>
          <c:order val="1"/>
          <c:tx>
            <c:v>sh#1</c:v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Hoja1!$E$25:$E$28;Hoja1!$I$25:$I$28;Hoja1!$M$25:$M$28)</c:f>
                <c:numCache>
                  <c:formatCode>General</c:formatCode>
                  <c:ptCount val="12"/>
                  <c:pt idx="0">
                    <c:v>0.13320175219029001</c:v>
                  </c:pt>
                  <c:pt idx="1">
                    <c:v>0.13591676719176399</c:v>
                  </c:pt>
                  <c:pt idx="2">
                    <c:v>0.35441615637261298</c:v>
                  </c:pt>
                  <c:pt idx="3">
                    <c:v>0.15976194148086301</c:v>
                  </c:pt>
                  <c:pt idx="4">
                    <c:v>7.0066454128887706E-2</c:v>
                  </c:pt>
                  <c:pt idx="5">
                    <c:v>9.7467879743375493E-2</c:v>
                  </c:pt>
                  <c:pt idx="6">
                    <c:v>8.2290815257071506E-2</c:v>
                  </c:pt>
                  <c:pt idx="7">
                    <c:v>0.10032653296757101</c:v>
                  </c:pt>
                  <c:pt idx="8">
                    <c:v>6.9970215664457394E-2</c:v>
                  </c:pt>
                  <c:pt idx="9">
                    <c:v>0.31858033141131098</c:v>
                  </c:pt>
                  <c:pt idx="10">
                    <c:v>0.20459931028994099</c:v>
                  </c:pt>
                  <c:pt idx="11">
                    <c:v>8.888129514132750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Hoja1!$A$21:$B$36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215</c:v>
                  </c:pt>
                  <c:pt idx="4">
                    <c:v>253</c:v>
                  </c:pt>
                  <c:pt idx="8">
                    <c:v>354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(Hoja1!$C$25:$C$28;Hoja1!$G$25:$G$28;Hoja1!$K$25:$K$28)</c:f>
              <c:numCache>
                <c:formatCode>General</c:formatCode>
                <c:ptCount val="12"/>
                <c:pt idx="0">
                  <c:v>1.0776006961835349</c:v>
                </c:pt>
                <c:pt idx="1">
                  <c:v>1.0080988098100749</c:v>
                </c:pt>
                <c:pt idx="2">
                  <c:v>1.4776209580929061</c:v>
                </c:pt>
                <c:pt idx="3">
                  <c:v>0.91085953697309996</c:v>
                </c:pt>
                <c:pt idx="4">
                  <c:v>1.023060442039009</c:v>
                </c:pt>
                <c:pt idx="5">
                  <c:v>0.91613751654742603</c:v>
                </c:pt>
                <c:pt idx="6">
                  <c:v>0.79748505856741503</c:v>
                </c:pt>
                <c:pt idx="7">
                  <c:v>0.69943528621168705</c:v>
                </c:pt>
                <c:pt idx="8">
                  <c:v>1.020782756682036</c:v>
                </c:pt>
                <c:pt idx="9">
                  <c:v>1.534745430659392</c:v>
                </c:pt>
                <c:pt idx="10">
                  <c:v>1.829787786963637</c:v>
                </c:pt>
                <c:pt idx="11">
                  <c:v>1.080083586282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B6-4EC6-9CE3-C0C604D08C58}"/>
            </c:ext>
          </c:extLst>
        </c:ser>
        <c:ser>
          <c:idx val="2"/>
          <c:order val="2"/>
          <c:tx>
            <c:v>sh#2</c:v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Hoja1!$E$29:$E$32;Hoja1!$I$29:$I$32;Hoja1!$M$29:$M$32)</c:f>
                <c:numCache>
                  <c:formatCode>General</c:formatCode>
                  <c:ptCount val="12"/>
                  <c:pt idx="0">
                    <c:v>0.15938330966491901</c:v>
                  </c:pt>
                  <c:pt idx="1">
                    <c:v>0.33960089062634902</c:v>
                  </c:pt>
                  <c:pt idx="2">
                    <c:v>0.35858617170734403</c:v>
                  </c:pt>
                  <c:pt idx="3">
                    <c:v>0.14279179798276601</c:v>
                  </c:pt>
                  <c:pt idx="4">
                    <c:v>8.5441097372422101E-2</c:v>
                  </c:pt>
                  <c:pt idx="5">
                    <c:v>0.184128965989792</c:v>
                  </c:pt>
                  <c:pt idx="6">
                    <c:v>8.3240493526904699E-2</c:v>
                  </c:pt>
                  <c:pt idx="7">
                    <c:v>0.120850275623491</c:v>
                  </c:pt>
                  <c:pt idx="8">
                    <c:v>9.2545995527636704E-2</c:v>
                  </c:pt>
                  <c:pt idx="9">
                    <c:v>0.21058373736085301</c:v>
                  </c:pt>
                  <c:pt idx="10">
                    <c:v>0.15910895876103301</c:v>
                  </c:pt>
                  <c:pt idx="11">
                    <c:v>0.235324540932810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Hoja1!$A$21:$B$36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215</c:v>
                  </c:pt>
                  <c:pt idx="4">
                    <c:v>253</c:v>
                  </c:pt>
                  <c:pt idx="8">
                    <c:v>354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(Hoja1!$C$29:$C$32;Hoja1!$G$29:$G$32;Hoja1!$K$29:$K$32)</c:f>
              <c:numCache>
                <c:formatCode>General</c:formatCode>
                <c:ptCount val="12"/>
                <c:pt idx="0">
                  <c:v>1.091024841625541</c:v>
                </c:pt>
                <c:pt idx="1">
                  <c:v>1.7675346034530071</c:v>
                </c:pt>
                <c:pt idx="2">
                  <c:v>1.584755125189407</c:v>
                </c:pt>
                <c:pt idx="3">
                  <c:v>0.81957374229685498</c:v>
                </c:pt>
                <c:pt idx="4">
                  <c:v>1.029488277179907</c:v>
                </c:pt>
                <c:pt idx="5">
                  <c:v>1.2061385893018659</c:v>
                </c:pt>
                <c:pt idx="6">
                  <c:v>0.90303682927629303</c:v>
                </c:pt>
                <c:pt idx="7">
                  <c:v>1.14311363130628</c:v>
                </c:pt>
                <c:pt idx="8">
                  <c:v>1.0462002992527839</c:v>
                </c:pt>
                <c:pt idx="9">
                  <c:v>0.99205528290808898</c:v>
                </c:pt>
                <c:pt idx="10">
                  <c:v>1.3556345325884711</c:v>
                </c:pt>
                <c:pt idx="11">
                  <c:v>1.2278357926580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AB6-4EC6-9CE3-C0C604D08C58}"/>
            </c:ext>
          </c:extLst>
        </c:ser>
        <c:ser>
          <c:idx val="3"/>
          <c:order val="3"/>
          <c:tx>
            <c:v>sh#3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Hoja1!$E$33:$E$36;Hoja1!$I$33:$I$36;Hoja1!$M$33:$M$36)</c:f>
                <c:numCache>
                  <c:formatCode>General</c:formatCode>
                  <c:ptCount val="12"/>
                  <c:pt idx="0">
                    <c:v>9.7015716464914303E-2</c:v>
                  </c:pt>
                  <c:pt idx="1">
                    <c:v>0.43820286232002098</c:v>
                  </c:pt>
                  <c:pt idx="2">
                    <c:v>0.19317044382078299</c:v>
                  </c:pt>
                  <c:pt idx="3">
                    <c:v>0.19693332931680399</c:v>
                  </c:pt>
                  <c:pt idx="4">
                    <c:v>5.8976149043907397E-2</c:v>
                  </c:pt>
                  <c:pt idx="5">
                    <c:v>0.11565551918379301</c:v>
                  </c:pt>
                  <c:pt idx="6">
                    <c:v>5.3222172080116301E-2</c:v>
                  </c:pt>
                  <c:pt idx="7">
                    <c:v>0.100428243655016</c:v>
                  </c:pt>
                  <c:pt idx="8">
                    <c:v>4.58022601369205E-2</c:v>
                  </c:pt>
                  <c:pt idx="9">
                    <c:v>0.21959937096600399</c:v>
                  </c:pt>
                  <c:pt idx="10">
                    <c:v>0.25307564301743202</c:v>
                  </c:pt>
                  <c:pt idx="11">
                    <c:v>0.877709450530121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Hoja1!$A$21:$B$36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215</c:v>
                  </c:pt>
                  <c:pt idx="4">
                    <c:v>253</c:v>
                  </c:pt>
                  <c:pt idx="8">
                    <c:v>354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(Hoja1!$C$33:$C$36;Hoja1!$G$33:$G$36;Hoja1!$K$33:$K$36)</c:f>
              <c:numCache>
                <c:formatCode>General</c:formatCode>
                <c:ptCount val="12"/>
                <c:pt idx="0">
                  <c:v>1.0408142025777609</c:v>
                </c:pt>
                <c:pt idx="1">
                  <c:v>1.34496121913244</c:v>
                </c:pt>
                <c:pt idx="2">
                  <c:v>1.224812391216427</c:v>
                </c:pt>
                <c:pt idx="3">
                  <c:v>1.1254332415175099</c:v>
                </c:pt>
                <c:pt idx="4">
                  <c:v>1.015491888769037</c:v>
                </c:pt>
                <c:pt idx="5">
                  <c:v>1.3229467950991971</c:v>
                </c:pt>
                <c:pt idx="6">
                  <c:v>1.176012965710262</c:v>
                </c:pt>
                <c:pt idx="7">
                  <c:v>1.528307198937578</c:v>
                </c:pt>
                <c:pt idx="8">
                  <c:v>1.0095376498017601</c:v>
                </c:pt>
                <c:pt idx="9">
                  <c:v>1.151472215560255</c:v>
                </c:pt>
                <c:pt idx="10">
                  <c:v>1.6591562532150059</c:v>
                </c:pt>
                <c:pt idx="11">
                  <c:v>2.87532898444095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AB6-4EC6-9CE3-C0C604D08C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5234448"/>
        <c:axId val="285235008"/>
      </c:barChart>
      <c:catAx>
        <c:axId val="28523444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285235008"/>
        <c:crosses val="autoZero"/>
        <c:auto val="1"/>
        <c:lblAlgn val="ctr"/>
        <c:lblOffset val="100"/>
        <c:noMultiLvlLbl val="0"/>
      </c:catAx>
      <c:valAx>
        <c:axId val="2852350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285234448"/>
        <c:crosses val="autoZero"/>
        <c:crossBetween val="between"/>
        <c:majorUnit val="2"/>
      </c:valAx>
      <c:spPr>
        <a:ln>
          <a:solidFill>
            <a:schemeClr val="tx1"/>
          </a:solidFill>
        </a:ln>
      </c:spPr>
    </c:plotArea>
    <c:legend>
      <c:legendPos val="t"/>
      <c:layout>
        <c:manualLayout>
          <c:xMode val="edge"/>
          <c:yMode val="edge"/>
          <c:x val="0.1095194545846612"/>
          <c:y val="0.20177679028144233"/>
          <c:w val="0.40603955352981402"/>
          <c:h val="6.7704898211296993E-2"/>
        </c:manualLayout>
      </c:layout>
      <c:overlay val="0"/>
      <c:txPr>
        <a:bodyPr/>
        <a:lstStyle/>
        <a:p>
          <a:pPr>
            <a:defRPr sz="900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1047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0" name="Group 469">
            <a:extLst>
              <a:ext uri="{FF2B5EF4-FFF2-40B4-BE49-F238E27FC236}">
                <a16:creationId xmlns:a16="http://schemas.microsoft.com/office/drawing/2014/main" id="{B6898694-3FD8-9248-A454-86CC378BA2C6}"/>
              </a:ext>
            </a:extLst>
          </p:cNvPr>
          <p:cNvGrpSpPr/>
          <p:nvPr/>
        </p:nvGrpSpPr>
        <p:grpSpPr>
          <a:xfrm>
            <a:off x="291961" y="1639382"/>
            <a:ext cx="4784373" cy="2699371"/>
            <a:chOff x="830431" y="6732198"/>
            <a:chExt cx="4104403" cy="2342410"/>
          </a:xfrm>
        </p:grpSpPr>
        <p:graphicFrame>
          <p:nvGraphicFramePr>
            <p:cNvPr id="471" name="Chart 2">
              <a:extLst>
                <a:ext uri="{FF2B5EF4-FFF2-40B4-BE49-F238E27FC236}">
                  <a16:creationId xmlns:a16="http://schemas.microsoft.com/office/drawing/2014/main" id="{D467A3B8-51E8-E949-A089-652538406B8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908746" y="6732198"/>
            <a:ext cx="4026088" cy="19746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72" name="TextBox 53">
              <a:extLst>
                <a:ext uri="{FF2B5EF4-FFF2-40B4-BE49-F238E27FC236}">
                  <a16:creationId xmlns:a16="http://schemas.microsoft.com/office/drawing/2014/main" id="{1AC87A51-6A89-2B49-80AC-5A9305CBC915}"/>
                </a:ext>
              </a:extLst>
            </p:cNvPr>
            <p:cNvSpPr txBox="1"/>
            <p:nvPr/>
          </p:nvSpPr>
          <p:spPr>
            <a:xfrm rot="16200000">
              <a:off x="25480" y="7776702"/>
              <a:ext cx="1821129" cy="2112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YC/PGC1A ratio (fold change)</a:t>
              </a:r>
            </a:p>
          </p:txBody>
        </p:sp>
        <p:sp>
          <p:nvSpPr>
            <p:cNvPr id="473" name="TextBox 138">
              <a:extLst>
                <a:ext uri="{FF2B5EF4-FFF2-40B4-BE49-F238E27FC236}">
                  <a16:creationId xmlns:a16="http://schemas.microsoft.com/office/drawing/2014/main" id="{6A9AD2AF-BEF7-9045-860A-8C702AF2486D}"/>
                </a:ext>
              </a:extLst>
            </p:cNvPr>
            <p:cNvSpPr txBox="1"/>
            <p:nvPr/>
          </p:nvSpPr>
          <p:spPr>
            <a:xfrm rot="16200000">
              <a:off x="1523809" y="8560414"/>
              <a:ext cx="33255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sp>
          <p:nvSpPr>
            <p:cNvPr id="474" name="TextBox 139">
              <a:extLst>
                <a:ext uri="{FF2B5EF4-FFF2-40B4-BE49-F238E27FC236}">
                  <a16:creationId xmlns:a16="http://schemas.microsoft.com/office/drawing/2014/main" id="{E1D804FD-6FAB-5042-AC25-FC75D58D0CF4}"/>
                </a:ext>
              </a:extLst>
            </p:cNvPr>
            <p:cNvSpPr txBox="1"/>
            <p:nvPr/>
          </p:nvSpPr>
          <p:spPr>
            <a:xfrm rot="16200000">
              <a:off x="1849801" y="8526314"/>
              <a:ext cx="26435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5" name="TextBox 139">
              <a:extLst>
                <a:ext uri="{FF2B5EF4-FFF2-40B4-BE49-F238E27FC236}">
                  <a16:creationId xmlns:a16="http://schemas.microsoft.com/office/drawing/2014/main" id="{24CE3430-738C-9341-AB96-5DF034FF5975}"/>
                </a:ext>
              </a:extLst>
            </p:cNvPr>
            <p:cNvSpPr txBox="1"/>
            <p:nvPr/>
          </p:nvSpPr>
          <p:spPr>
            <a:xfrm rot="16200000">
              <a:off x="2111472" y="8569073"/>
              <a:ext cx="34987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-165</a:t>
              </a:r>
            </a:p>
          </p:txBody>
        </p:sp>
        <p:sp>
          <p:nvSpPr>
            <p:cNvPr id="476" name="TextBox 138">
              <a:extLst>
                <a:ext uri="{FF2B5EF4-FFF2-40B4-BE49-F238E27FC236}">
                  <a16:creationId xmlns:a16="http://schemas.microsoft.com/office/drawing/2014/main" id="{B6F0AEBD-A2F1-524B-9A96-6A1CC47E60C7}"/>
                </a:ext>
              </a:extLst>
            </p:cNvPr>
            <p:cNvSpPr txBox="1"/>
            <p:nvPr/>
          </p:nvSpPr>
          <p:spPr>
            <a:xfrm rot="16200000">
              <a:off x="1199003" y="8555542"/>
              <a:ext cx="322810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7" name="237 Conector recto">
              <a:extLst>
                <a:ext uri="{FF2B5EF4-FFF2-40B4-BE49-F238E27FC236}">
                  <a16:creationId xmlns:a16="http://schemas.microsoft.com/office/drawing/2014/main" id="{FDDB4E8B-4FEF-734C-85DC-10E510FD011B}"/>
                </a:ext>
              </a:extLst>
            </p:cNvPr>
            <p:cNvCxnSpPr/>
            <p:nvPr/>
          </p:nvCxnSpPr>
          <p:spPr>
            <a:xfrm>
              <a:off x="1300500" y="8914399"/>
              <a:ext cx="10581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8" name="238 CuadroTexto">
              <a:extLst>
                <a:ext uri="{FF2B5EF4-FFF2-40B4-BE49-F238E27FC236}">
                  <a16:creationId xmlns:a16="http://schemas.microsoft.com/office/drawing/2014/main" id="{E9ECDB2D-317B-604C-ABB7-EDEE6FAFFE4C}"/>
                </a:ext>
              </a:extLst>
            </p:cNvPr>
            <p:cNvSpPr txBox="1"/>
            <p:nvPr/>
          </p:nvSpPr>
          <p:spPr>
            <a:xfrm>
              <a:off x="1636547" y="8903136"/>
              <a:ext cx="402385" cy="1714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215</a:t>
              </a:r>
            </a:p>
          </p:txBody>
        </p:sp>
        <p:sp>
          <p:nvSpPr>
            <p:cNvPr id="479" name="TextBox 138">
              <a:extLst>
                <a:ext uri="{FF2B5EF4-FFF2-40B4-BE49-F238E27FC236}">
                  <a16:creationId xmlns:a16="http://schemas.microsoft.com/office/drawing/2014/main" id="{A262B937-AC43-AA4C-8E85-FB5D85DB2BE4}"/>
                </a:ext>
              </a:extLst>
            </p:cNvPr>
            <p:cNvSpPr txBox="1"/>
            <p:nvPr/>
          </p:nvSpPr>
          <p:spPr>
            <a:xfrm rot="16200000">
              <a:off x="2726686" y="8560414"/>
              <a:ext cx="33255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sp>
          <p:nvSpPr>
            <p:cNvPr id="480" name="TextBox 139">
              <a:extLst>
                <a:ext uri="{FF2B5EF4-FFF2-40B4-BE49-F238E27FC236}">
                  <a16:creationId xmlns:a16="http://schemas.microsoft.com/office/drawing/2014/main" id="{6A7944A4-1205-3D43-8A9E-0F55C9F2C782}"/>
                </a:ext>
              </a:extLst>
            </p:cNvPr>
            <p:cNvSpPr txBox="1"/>
            <p:nvPr/>
          </p:nvSpPr>
          <p:spPr>
            <a:xfrm rot="16200000">
              <a:off x="3052678" y="8526314"/>
              <a:ext cx="26435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1" name="TextBox 480">
              <a:extLst>
                <a:ext uri="{FF2B5EF4-FFF2-40B4-BE49-F238E27FC236}">
                  <a16:creationId xmlns:a16="http://schemas.microsoft.com/office/drawing/2014/main" id="{073419BD-7439-8743-8AA4-7C95A9B25E12}"/>
                </a:ext>
              </a:extLst>
            </p:cNvPr>
            <p:cNvSpPr txBox="1"/>
            <p:nvPr/>
          </p:nvSpPr>
          <p:spPr>
            <a:xfrm rot="16200000">
              <a:off x="3321516" y="8569073"/>
              <a:ext cx="34987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-165</a:t>
              </a:r>
            </a:p>
          </p:txBody>
        </p:sp>
        <p:sp>
          <p:nvSpPr>
            <p:cNvPr id="482" name="TextBox 138">
              <a:extLst>
                <a:ext uri="{FF2B5EF4-FFF2-40B4-BE49-F238E27FC236}">
                  <a16:creationId xmlns:a16="http://schemas.microsoft.com/office/drawing/2014/main" id="{EE2C8741-3F95-E645-BFC0-AAD574CCF96E}"/>
                </a:ext>
              </a:extLst>
            </p:cNvPr>
            <p:cNvSpPr txBox="1"/>
            <p:nvPr/>
          </p:nvSpPr>
          <p:spPr>
            <a:xfrm rot="16200000">
              <a:off x="2425950" y="8555542"/>
              <a:ext cx="322810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3" name="TextBox 138">
              <a:extLst>
                <a:ext uri="{FF2B5EF4-FFF2-40B4-BE49-F238E27FC236}">
                  <a16:creationId xmlns:a16="http://schemas.microsoft.com/office/drawing/2014/main" id="{3BACBA16-EEDB-A649-A9E7-B3ADD5197A67}"/>
                </a:ext>
              </a:extLst>
            </p:cNvPr>
            <p:cNvSpPr txBox="1"/>
            <p:nvPr/>
          </p:nvSpPr>
          <p:spPr>
            <a:xfrm rot="16200000">
              <a:off x="3905493" y="8560414"/>
              <a:ext cx="33255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sp>
          <p:nvSpPr>
            <p:cNvPr id="484" name="TextBox 139">
              <a:extLst>
                <a:ext uri="{FF2B5EF4-FFF2-40B4-BE49-F238E27FC236}">
                  <a16:creationId xmlns:a16="http://schemas.microsoft.com/office/drawing/2014/main" id="{A08F6DE0-787E-B740-965C-6E6252A4190C}"/>
                </a:ext>
              </a:extLst>
            </p:cNvPr>
            <p:cNvSpPr txBox="1"/>
            <p:nvPr/>
          </p:nvSpPr>
          <p:spPr>
            <a:xfrm rot="16200000">
              <a:off x="4254270" y="8526314"/>
              <a:ext cx="26435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5" name="TextBox 139">
              <a:extLst>
                <a:ext uri="{FF2B5EF4-FFF2-40B4-BE49-F238E27FC236}">
                  <a16:creationId xmlns:a16="http://schemas.microsoft.com/office/drawing/2014/main" id="{0E243644-162C-DD4D-ADEF-B43DAD5E96B8}"/>
                </a:ext>
              </a:extLst>
            </p:cNvPr>
            <p:cNvSpPr txBox="1"/>
            <p:nvPr/>
          </p:nvSpPr>
          <p:spPr>
            <a:xfrm rot="16200000">
              <a:off x="4478031" y="8569074"/>
              <a:ext cx="349873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-165</a:t>
              </a:r>
            </a:p>
          </p:txBody>
        </p:sp>
        <p:sp>
          <p:nvSpPr>
            <p:cNvPr id="486" name="TextBox 138">
              <a:extLst>
                <a:ext uri="{FF2B5EF4-FFF2-40B4-BE49-F238E27FC236}">
                  <a16:creationId xmlns:a16="http://schemas.microsoft.com/office/drawing/2014/main" id="{366B7291-9190-694D-9283-B1930B72F9F7}"/>
                </a:ext>
              </a:extLst>
            </p:cNvPr>
            <p:cNvSpPr txBox="1"/>
            <p:nvPr/>
          </p:nvSpPr>
          <p:spPr>
            <a:xfrm rot="16200000">
              <a:off x="3611924" y="8555542"/>
              <a:ext cx="322810" cy="2412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7" name="247 Conector recto">
              <a:extLst>
                <a:ext uri="{FF2B5EF4-FFF2-40B4-BE49-F238E27FC236}">
                  <a16:creationId xmlns:a16="http://schemas.microsoft.com/office/drawing/2014/main" id="{636DEA3B-91D6-5C4E-8F90-30A7AF55CD21}"/>
                </a:ext>
              </a:extLst>
            </p:cNvPr>
            <p:cNvCxnSpPr/>
            <p:nvPr/>
          </p:nvCxnSpPr>
          <p:spPr>
            <a:xfrm>
              <a:off x="2498857" y="8914399"/>
              <a:ext cx="10581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8" name="248 Conector recto">
              <a:extLst>
                <a:ext uri="{FF2B5EF4-FFF2-40B4-BE49-F238E27FC236}">
                  <a16:creationId xmlns:a16="http://schemas.microsoft.com/office/drawing/2014/main" id="{2244DA42-3856-624E-B7CF-95910AB2B502}"/>
                </a:ext>
              </a:extLst>
            </p:cNvPr>
            <p:cNvCxnSpPr/>
            <p:nvPr/>
          </p:nvCxnSpPr>
          <p:spPr>
            <a:xfrm>
              <a:off x="3694567" y="8914399"/>
              <a:ext cx="10581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9" name="249 CuadroTexto">
              <a:extLst>
                <a:ext uri="{FF2B5EF4-FFF2-40B4-BE49-F238E27FC236}">
                  <a16:creationId xmlns:a16="http://schemas.microsoft.com/office/drawing/2014/main" id="{A586FE27-210B-0A4E-9AA4-F38A4565B5F3}"/>
                </a:ext>
              </a:extLst>
            </p:cNvPr>
            <p:cNvSpPr txBox="1"/>
            <p:nvPr/>
          </p:nvSpPr>
          <p:spPr>
            <a:xfrm>
              <a:off x="2842764" y="8903136"/>
              <a:ext cx="402385" cy="1714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253</a:t>
              </a:r>
            </a:p>
          </p:txBody>
        </p:sp>
        <p:sp>
          <p:nvSpPr>
            <p:cNvPr id="490" name="250 CuadroTexto">
              <a:extLst>
                <a:ext uri="{FF2B5EF4-FFF2-40B4-BE49-F238E27FC236}">
                  <a16:creationId xmlns:a16="http://schemas.microsoft.com/office/drawing/2014/main" id="{4CDCDB9A-D358-F74E-A147-F9366D22A309}"/>
                </a:ext>
              </a:extLst>
            </p:cNvPr>
            <p:cNvSpPr txBox="1"/>
            <p:nvPr/>
          </p:nvSpPr>
          <p:spPr>
            <a:xfrm>
              <a:off x="4038314" y="8903136"/>
              <a:ext cx="402385" cy="1714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54</a:t>
              </a:r>
            </a:p>
          </p:txBody>
        </p:sp>
        <p:sp>
          <p:nvSpPr>
            <p:cNvPr id="491" name="TextBox 184">
              <a:extLst>
                <a:ext uri="{FF2B5EF4-FFF2-40B4-BE49-F238E27FC236}">
                  <a16:creationId xmlns:a16="http://schemas.microsoft.com/office/drawing/2014/main" id="{326AF84F-DC4D-1946-8508-D99F0D96F41E}"/>
                </a:ext>
              </a:extLst>
            </p:cNvPr>
            <p:cNvSpPr txBox="1"/>
            <p:nvPr/>
          </p:nvSpPr>
          <p:spPr>
            <a:xfrm>
              <a:off x="1620205" y="8087884"/>
              <a:ext cx="229620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492" name="Straight Connector 176">
              <a:extLst>
                <a:ext uri="{FF2B5EF4-FFF2-40B4-BE49-F238E27FC236}">
                  <a16:creationId xmlns:a16="http://schemas.microsoft.com/office/drawing/2014/main" id="{596BF4EC-52E1-3541-AA66-55D827F950BC}"/>
                </a:ext>
              </a:extLst>
            </p:cNvPr>
            <p:cNvCxnSpPr/>
            <p:nvPr/>
          </p:nvCxnSpPr>
          <p:spPr>
            <a:xfrm>
              <a:off x="1648312" y="8233450"/>
              <a:ext cx="141088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3" name="TextBox 184">
              <a:extLst>
                <a:ext uri="{FF2B5EF4-FFF2-40B4-BE49-F238E27FC236}">
                  <a16:creationId xmlns:a16="http://schemas.microsoft.com/office/drawing/2014/main" id="{8DA4194C-C90A-7747-B37D-E1D4BF091AC1}"/>
                </a:ext>
              </a:extLst>
            </p:cNvPr>
            <p:cNvSpPr txBox="1"/>
            <p:nvPr/>
          </p:nvSpPr>
          <p:spPr>
            <a:xfrm>
              <a:off x="1922172" y="8108039"/>
              <a:ext cx="229620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494" name="Straight Connector 176">
              <a:extLst>
                <a:ext uri="{FF2B5EF4-FFF2-40B4-BE49-F238E27FC236}">
                  <a16:creationId xmlns:a16="http://schemas.microsoft.com/office/drawing/2014/main" id="{48FBD1C0-3AAF-4948-9100-36887604404B}"/>
                </a:ext>
              </a:extLst>
            </p:cNvPr>
            <p:cNvCxnSpPr/>
            <p:nvPr/>
          </p:nvCxnSpPr>
          <p:spPr>
            <a:xfrm>
              <a:off x="1953971" y="8243789"/>
              <a:ext cx="141088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5" name="TextBox 184">
              <a:extLst>
                <a:ext uri="{FF2B5EF4-FFF2-40B4-BE49-F238E27FC236}">
                  <a16:creationId xmlns:a16="http://schemas.microsoft.com/office/drawing/2014/main" id="{85CB8E08-CD9D-734C-AA81-D9DB9F666D5A}"/>
                </a:ext>
              </a:extLst>
            </p:cNvPr>
            <p:cNvSpPr txBox="1"/>
            <p:nvPr/>
          </p:nvSpPr>
          <p:spPr>
            <a:xfrm>
              <a:off x="2211978" y="8165318"/>
              <a:ext cx="229620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496" name="Straight Connector 176">
              <a:extLst>
                <a:ext uri="{FF2B5EF4-FFF2-40B4-BE49-F238E27FC236}">
                  <a16:creationId xmlns:a16="http://schemas.microsoft.com/office/drawing/2014/main" id="{3B08C548-BB65-7843-8C62-04BACE81EA79}"/>
                </a:ext>
              </a:extLst>
            </p:cNvPr>
            <p:cNvCxnSpPr/>
            <p:nvPr/>
          </p:nvCxnSpPr>
          <p:spPr>
            <a:xfrm>
              <a:off x="2250953" y="8309501"/>
              <a:ext cx="141088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7" name="TextBox 184">
              <a:extLst>
                <a:ext uri="{FF2B5EF4-FFF2-40B4-BE49-F238E27FC236}">
                  <a16:creationId xmlns:a16="http://schemas.microsoft.com/office/drawing/2014/main" id="{E9902A02-C966-BA4F-8849-7F59180D2776}"/>
                </a:ext>
              </a:extLst>
            </p:cNvPr>
            <p:cNvSpPr txBox="1"/>
            <p:nvPr/>
          </p:nvSpPr>
          <p:spPr>
            <a:xfrm>
              <a:off x="2761048" y="8154887"/>
              <a:ext cx="326997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498" name="Straight Connector 176">
              <a:extLst>
                <a:ext uri="{FF2B5EF4-FFF2-40B4-BE49-F238E27FC236}">
                  <a16:creationId xmlns:a16="http://schemas.microsoft.com/office/drawing/2014/main" id="{2890601C-589D-3E46-999F-3FAF39535DEA}"/>
                </a:ext>
              </a:extLst>
            </p:cNvPr>
            <p:cNvCxnSpPr/>
            <p:nvPr/>
          </p:nvCxnSpPr>
          <p:spPr>
            <a:xfrm>
              <a:off x="2852325" y="8295296"/>
              <a:ext cx="141088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9" name="TextBox 184">
              <a:extLst>
                <a:ext uri="{FF2B5EF4-FFF2-40B4-BE49-F238E27FC236}">
                  <a16:creationId xmlns:a16="http://schemas.microsoft.com/office/drawing/2014/main" id="{097B34BF-A331-6A47-847A-CE094FF5C910}"/>
                </a:ext>
              </a:extLst>
            </p:cNvPr>
            <p:cNvSpPr txBox="1"/>
            <p:nvPr/>
          </p:nvSpPr>
          <p:spPr>
            <a:xfrm>
              <a:off x="3087328" y="8193120"/>
              <a:ext cx="278308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500" name="Straight Connector 176">
              <a:extLst>
                <a:ext uri="{FF2B5EF4-FFF2-40B4-BE49-F238E27FC236}">
                  <a16:creationId xmlns:a16="http://schemas.microsoft.com/office/drawing/2014/main" id="{28A77995-ECCE-7442-8982-760BCA53F4E0}"/>
                </a:ext>
              </a:extLst>
            </p:cNvPr>
            <p:cNvCxnSpPr/>
            <p:nvPr/>
          </p:nvCxnSpPr>
          <p:spPr>
            <a:xfrm>
              <a:off x="3149936" y="8333529"/>
              <a:ext cx="141088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1" name="TextBox 184">
              <a:extLst>
                <a:ext uri="{FF2B5EF4-FFF2-40B4-BE49-F238E27FC236}">
                  <a16:creationId xmlns:a16="http://schemas.microsoft.com/office/drawing/2014/main" id="{E4F4F360-DDD0-604D-B0FA-C0D8DF95BA64}"/>
                </a:ext>
              </a:extLst>
            </p:cNvPr>
            <p:cNvSpPr txBox="1"/>
            <p:nvPr/>
          </p:nvSpPr>
          <p:spPr>
            <a:xfrm>
              <a:off x="3394347" y="8133511"/>
              <a:ext cx="278308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502" name="Straight Connector 139">
              <a:extLst>
                <a:ext uri="{FF2B5EF4-FFF2-40B4-BE49-F238E27FC236}">
                  <a16:creationId xmlns:a16="http://schemas.microsoft.com/office/drawing/2014/main" id="{3EAC4BB4-D7F4-4D47-99A9-3D1C16575BC6}"/>
                </a:ext>
              </a:extLst>
            </p:cNvPr>
            <p:cNvCxnSpPr/>
            <p:nvPr/>
          </p:nvCxnSpPr>
          <p:spPr>
            <a:xfrm>
              <a:off x="3449788" y="8280927"/>
              <a:ext cx="141088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3" name="TextBox 184">
              <a:extLst>
                <a:ext uri="{FF2B5EF4-FFF2-40B4-BE49-F238E27FC236}">
                  <a16:creationId xmlns:a16="http://schemas.microsoft.com/office/drawing/2014/main" id="{28E3EAC1-68E5-B944-8262-F3654D48EF9C}"/>
                </a:ext>
              </a:extLst>
            </p:cNvPr>
            <p:cNvSpPr txBox="1"/>
            <p:nvPr/>
          </p:nvSpPr>
          <p:spPr>
            <a:xfrm>
              <a:off x="3995008" y="8133613"/>
              <a:ext cx="278308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504" name="Straight Connector 176">
              <a:extLst>
                <a:ext uri="{FF2B5EF4-FFF2-40B4-BE49-F238E27FC236}">
                  <a16:creationId xmlns:a16="http://schemas.microsoft.com/office/drawing/2014/main" id="{9BF88E1B-2BCD-F742-9109-6EA04FD8261C}"/>
                </a:ext>
              </a:extLst>
            </p:cNvPr>
            <p:cNvCxnSpPr/>
            <p:nvPr/>
          </p:nvCxnSpPr>
          <p:spPr>
            <a:xfrm>
              <a:off x="4062960" y="8273625"/>
              <a:ext cx="10581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5" name="TextBox 184">
              <a:extLst>
                <a:ext uri="{FF2B5EF4-FFF2-40B4-BE49-F238E27FC236}">
                  <a16:creationId xmlns:a16="http://schemas.microsoft.com/office/drawing/2014/main" id="{6026516C-927E-2F44-AA0B-D54DB84D1CCB}"/>
                </a:ext>
              </a:extLst>
            </p:cNvPr>
            <p:cNvSpPr txBox="1"/>
            <p:nvPr/>
          </p:nvSpPr>
          <p:spPr>
            <a:xfrm>
              <a:off x="4265707" y="8094899"/>
              <a:ext cx="326997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506" name="Straight Connector 176">
              <a:extLst>
                <a:ext uri="{FF2B5EF4-FFF2-40B4-BE49-F238E27FC236}">
                  <a16:creationId xmlns:a16="http://schemas.microsoft.com/office/drawing/2014/main" id="{9B8902FA-E9D9-9E47-949F-B1F4D60B3FC8}"/>
                </a:ext>
              </a:extLst>
            </p:cNvPr>
            <p:cNvCxnSpPr/>
            <p:nvPr/>
          </p:nvCxnSpPr>
          <p:spPr>
            <a:xfrm>
              <a:off x="4356797" y="8239617"/>
              <a:ext cx="141088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7" name="TextBox 184">
              <a:extLst>
                <a:ext uri="{FF2B5EF4-FFF2-40B4-BE49-F238E27FC236}">
                  <a16:creationId xmlns:a16="http://schemas.microsoft.com/office/drawing/2014/main" id="{6597D581-FEEB-DE46-ABDB-780F481CED33}"/>
                </a:ext>
              </a:extLst>
            </p:cNvPr>
            <p:cNvSpPr txBox="1"/>
            <p:nvPr/>
          </p:nvSpPr>
          <p:spPr>
            <a:xfrm>
              <a:off x="4601597" y="7922716"/>
              <a:ext cx="278308" cy="16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508" name="Straight Connector 176">
              <a:extLst>
                <a:ext uri="{FF2B5EF4-FFF2-40B4-BE49-F238E27FC236}">
                  <a16:creationId xmlns:a16="http://schemas.microsoft.com/office/drawing/2014/main" id="{038E3AB0-981C-7344-98A9-A94F5FAF7C48}"/>
                </a:ext>
              </a:extLst>
            </p:cNvPr>
            <p:cNvCxnSpPr/>
            <p:nvPr/>
          </p:nvCxnSpPr>
          <p:spPr>
            <a:xfrm>
              <a:off x="4669549" y="8056294"/>
              <a:ext cx="10581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9" name="TextBox 90">
              <a:extLst>
                <a:ext uri="{FF2B5EF4-FFF2-40B4-BE49-F238E27FC236}">
                  <a16:creationId xmlns:a16="http://schemas.microsoft.com/office/drawing/2014/main" id="{CF02B741-5C62-0D45-9418-4472E6A75C64}"/>
                </a:ext>
              </a:extLst>
            </p:cNvPr>
            <p:cNvSpPr txBox="1"/>
            <p:nvPr/>
          </p:nvSpPr>
          <p:spPr>
            <a:xfrm>
              <a:off x="3307257" y="7125304"/>
              <a:ext cx="229620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10" name="TextBox 90">
              <a:extLst>
                <a:ext uri="{FF2B5EF4-FFF2-40B4-BE49-F238E27FC236}">
                  <a16:creationId xmlns:a16="http://schemas.microsoft.com/office/drawing/2014/main" id="{8C28E4C4-BC6A-A04E-8A76-B05E892EAA92}"/>
                </a:ext>
              </a:extLst>
            </p:cNvPr>
            <p:cNvSpPr txBox="1"/>
            <p:nvPr/>
          </p:nvSpPr>
          <p:spPr>
            <a:xfrm>
              <a:off x="1790079" y="8006706"/>
              <a:ext cx="229620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11" name="TextBox 90">
              <a:extLst>
                <a:ext uri="{FF2B5EF4-FFF2-40B4-BE49-F238E27FC236}">
                  <a16:creationId xmlns:a16="http://schemas.microsoft.com/office/drawing/2014/main" id="{EC842403-B6A3-8143-A84E-1F0CC0F2999F}"/>
                </a:ext>
              </a:extLst>
            </p:cNvPr>
            <p:cNvSpPr txBox="1"/>
            <p:nvPr/>
          </p:nvSpPr>
          <p:spPr>
            <a:xfrm>
              <a:off x="2694654" y="7991414"/>
              <a:ext cx="229620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12" name="TextBox 90">
              <a:extLst>
                <a:ext uri="{FF2B5EF4-FFF2-40B4-BE49-F238E27FC236}">
                  <a16:creationId xmlns:a16="http://schemas.microsoft.com/office/drawing/2014/main" id="{7D1A1599-B0DD-3040-80B9-36413E0C81F9}"/>
                </a:ext>
              </a:extLst>
            </p:cNvPr>
            <p:cNvSpPr txBox="1"/>
            <p:nvPr/>
          </p:nvSpPr>
          <p:spPr>
            <a:xfrm>
              <a:off x="3896232" y="8106027"/>
              <a:ext cx="229620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13" name="TextBox 90">
              <a:extLst>
                <a:ext uri="{FF2B5EF4-FFF2-40B4-BE49-F238E27FC236}">
                  <a16:creationId xmlns:a16="http://schemas.microsoft.com/office/drawing/2014/main" id="{57AE95B7-10CD-F543-BD65-89CFCF2B0591}"/>
                </a:ext>
              </a:extLst>
            </p:cNvPr>
            <p:cNvSpPr txBox="1"/>
            <p:nvPr/>
          </p:nvSpPr>
          <p:spPr>
            <a:xfrm>
              <a:off x="1465510" y="8043951"/>
              <a:ext cx="278308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</a:p>
          </p:txBody>
        </p:sp>
        <p:sp>
          <p:nvSpPr>
            <p:cNvPr id="514" name="TextBox 90">
              <a:extLst>
                <a:ext uri="{FF2B5EF4-FFF2-40B4-BE49-F238E27FC236}">
                  <a16:creationId xmlns:a16="http://schemas.microsoft.com/office/drawing/2014/main" id="{6BD18698-8F31-7B4B-80A1-F4437648C12D}"/>
                </a:ext>
              </a:extLst>
            </p:cNvPr>
            <p:cNvSpPr txBox="1"/>
            <p:nvPr/>
          </p:nvSpPr>
          <p:spPr>
            <a:xfrm>
              <a:off x="2078849" y="8097532"/>
              <a:ext cx="278308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</a:p>
          </p:txBody>
        </p:sp>
        <p:sp>
          <p:nvSpPr>
            <p:cNvPr id="515" name="TextBox 90">
              <a:extLst>
                <a:ext uri="{FF2B5EF4-FFF2-40B4-BE49-F238E27FC236}">
                  <a16:creationId xmlns:a16="http://schemas.microsoft.com/office/drawing/2014/main" id="{51189564-AAB8-AD4A-9C65-5D1C5E12A33A}"/>
                </a:ext>
              </a:extLst>
            </p:cNvPr>
            <p:cNvSpPr txBox="1"/>
            <p:nvPr/>
          </p:nvSpPr>
          <p:spPr>
            <a:xfrm>
              <a:off x="4200441" y="7985420"/>
              <a:ext cx="229620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16" name="TextBox 90">
              <a:extLst>
                <a:ext uri="{FF2B5EF4-FFF2-40B4-BE49-F238E27FC236}">
                  <a16:creationId xmlns:a16="http://schemas.microsoft.com/office/drawing/2014/main" id="{3190DBA0-720B-9044-9C56-370D62CB87B9}"/>
                </a:ext>
              </a:extLst>
            </p:cNvPr>
            <p:cNvSpPr txBox="1"/>
            <p:nvPr/>
          </p:nvSpPr>
          <p:spPr>
            <a:xfrm>
              <a:off x="4493904" y="8065649"/>
              <a:ext cx="229620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17" name="TextBox 90">
              <a:extLst>
                <a:ext uri="{FF2B5EF4-FFF2-40B4-BE49-F238E27FC236}">
                  <a16:creationId xmlns:a16="http://schemas.microsoft.com/office/drawing/2014/main" id="{FC44553B-6F5E-D041-9242-BEA2E08AF116}"/>
                </a:ext>
              </a:extLst>
            </p:cNvPr>
            <p:cNvSpPr txBox="1"/>
            <p:nvPr/>
          </p:nvSpPr>
          <p:spPr>
            <a:xfrm>
              <a:off x="3001648" y="8134374"/>
              <a:ext cx="229620" cy="13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18" name="TextBox 10">
              <a:extLst>
                <a:ext uri="{FF2B5EF4-FFF2-40B4-BE49-F238E27FC236}">
                  <a16:creationId xmlns:a16="http://schemas.microsoft.com/office/drawing/2014/main" id="{936750B2-2BA5-5F41-8010-5940A3CD8823}"/>
                </a:ext>
              </a:extLst>
            </p:cNvPr>
            <p:cNvSpPr txBox="1"/>
            <p:nvPr/>
          </p:nvSpPr>
          <p:spPr>
            <a:xfrm>
              <a:off x="2858775" y="7092808"/>
              <a:ext cx="576719" cy="155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ARD</a:t>
              </a:r>
            </a:p>
          </p:txBody>
        </p:sp>
        <p:cxnSp>
          <p:nvCxnSpPr>
            <p:cNvPr id="519" name="Straight Connector 18">
              <a:extLst>
                <a:ext uri="{FF2B5EF4-FFF2-40B4-BE49-F238E27FC236}">
                  <a16:creationId xmlns:a16="http://schemas.microsoft.com/office/drawing/2014/main" id="{BB6F4B64-CC3E-EE46-80B1-67C6B7F95F5A}"/>
                </a:ext>
              </a:extLst>
            </p:cNvPr>
            <p:cNvCxnSpPr/>
            <p:nvPr/>
          </p:nvCxnSpPr>
          <p:spPr>
            <a:xfrm>
              <a:off x="1238011" y="8450984"/>
              <a:ext cx="359774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0" name="TextBox 3">
            <a:extLst>
              <a:ext uri="{FF2B5EF4-FFF2-40B4-BE49-F238E27FC236}">
                <a16:creationId xmlns:a16="http://schemas.microsoft.com/office/drawing/2014/main" id="{0C23D540-5296-92EC-39FA-943BAF72DE20}"/>
              </a:ext>
            </a:extLst>
          </p:cNvPr>
          <p:cNvSpPr txBox="1"/>
          <p:nvPr/>
        </p:nvSpPr>
        <p:spPr>
          <a:xfrm>
            <a:off x="0" y="0"/>
            <a:ext cx="6880680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Figure S11, related to Figure 6</a:t>
            </a:r>
          </a:p>
          <a:p>
            <a:pPr algn="just"/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PAR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ontrols cellular metabolism via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YC/PGC1A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ratio to promote epithelial-to-mesenchymal </a:t>
            </a:r>
            <a:r>
              <a:rPr lang="en-US" sz="1000" b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ransition</a:t>
            </a:r>
            <a:r>
              <a:rPr lang="en-US" sz="100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PDAC-215, 253, and 354 cells transduced with a non-targeting shRNA (NT) or three different shRNA against PPA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(sh#1, sh#2, sh#3) were incubated with MCM or Eto or the PPA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gonist L-165 for 48h to determine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/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GC1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expression upon indicated treatments.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ells transduced with lentiviral constructs were pretreated with doxycycline for 48h before treatments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All data are represented as mean ± SEM. * p&lt;0.05, ** p&lt;0.01, *** p&lt;0.001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v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NT cells; # p&lt;0.05, ## p&lt;0.01, ### p&lt;0.001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v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control or single treatment.</a:t>
            </a:r>
            <a:endParaRPr lang="en-US" sz="1000" dirty="0">
              <a:highlight>
                <a:srgbClr val="FFFF00"/>
              </a:highlight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3388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2</Words>
  <Application>Microsoft Macintosh PowerPoint</Application>
  <PresentationFormat>Presentación en pantalla (4:3)</PresentationFormat>
  <Paragraphs>3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7:57Z</dcterms:modified>
</cp:coreProperties>
</file>